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5DD9C21-8457-4C41-9C73-2171BA46D9A8}" v="11" dt="2025-08-28T06:07:01.4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13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97397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64652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5409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7612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77695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90057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94018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06321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83595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8798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57969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4308B-F40B-43EC-8966-4DF3594D3842}" type="datetimeFigureOut">
              <a:rPr lang="zh-TW" altLang="en-US" smtClean="0"/>
              <a:t>2025/9/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C0843-D00D-4429-898B-30E7956DDBA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817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11.wdp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9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12.wdp"/><Relationship Id="rId7" Type="http://schemas.microsoft.com/office/2007/relationships/hdphoto" Target="../media/hdphoto14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microsoft.com/office/2007/relationships/hdphoto" Target="../media/hdphoto16.wdp"/><Relationship Id="rId5" Type="http://schemas.microsoft.com/office/2007/relationships/hdphoto" Target="../media/hdphoto13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15.wdp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7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8.wdp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2826" y="1767160"/>
            <a:ext cx="3599688" cy="2878836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1911178" y="3286897"/>
            <a:ext cx="2405449" cy="3130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文字方塊 6"/>
          <p:cNvSpPr txBox="1"/>
          <p:nvPr/>
        </p:nvSpPr>
        <p:spPr>
          <a:xfrm>
            <a:off x="4567750" y="3244334"/>
            <a:ext cx="1383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err="1"/>
              <a:t>Occludin</a:t>
            </a:r>
            <a:endParaRPr lang="zh-TW" altLang="en-US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5086" y="1767160"/>
            <a:ext cx="3599688" cy="2878836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7022756" y="2574323"/>
            <a:ext cx="2615514" cy="3336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文字方塊 9"/>
          <p:cNvSpPr txBox="1"/>
          <p:nvPr/>
        </p:nvSpPr>
        <p:spPr>
          <a:xfrm>
            <a:off x="9638270" y="2538624"/>
            <a:ext cx="1383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CAEAA62C-AAF8-FA77-6286-079B4588FA2C}"/>
              </a:ext>
            </a:extLst>
          </p:cNvPr>
          <p:cNvSpPr txBox="1"/>
          <p:nvPr/>
        </p:nvSpPr>
        <p:spPr>
          <a:xfrm>
            <a:off x="0" y="0"/>
            <a:ext cx="17614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Figure 3C</a:t>
            </a:r>
            <a:endParaRPr lang="zh-TW" altLang="en-US" sz="3200" dirty="0"/>
          </a:p>
        </p:txBody>
      </p:sp>
    </p:spTree>
    <p:extLst>
      <p:ext uri="{BB962C8B-B14F-4D97-AF65-F5344CB8AC3E}">
        <p14:creationId xmlns:p14="http://schemas.microsoft.com/office/powerpoint/2010/main" val="1466067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645C9AED-A29D-31FD-9925-88F51C353AB1}"/>
              </a:ext>
            </a:extLst>
          </p:cNvPr>
          <p:cNvSpPr txBox="1"/>
          <p:nvPr/>
        </p:nvSpPr>
        <p:spPr>
          <a:xfrm>
            <a:off x="0" y="0"/>
            <a:ext cx="18095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Figure 4B</a:t>
            </a:r>
            <a:endParaRPr lang="zh-TW" altLang="en-US" sz="3200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16358EED-E7CC-1F66-29A3-7FB1476249F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1462" y="1552215"/>
            <a:ext cx="4698914" cy="375357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5200BF24-4961-3A27-EC26-393C9B1E58D4}"/>
              </a:ext>
            </a:extLst>
          </p:cNvPr>
          <p:cNvSpPr/>
          <p:nvPr/>
        </p:nvSpPr>
        <p:spPr>
          <a:xfrm>
            <a:off x="1640983" y="3271039"/>
            <a:ext cx="1351006" cy="288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A00500F1-6F82-A780-E9BE-E8FC85C4DE7F}"/>
              </a:ext>
            </a:extLst>
          </p:cNvPr>
          <p:cNvSpPr txBox="1"/>
          <p:nvPr/>
        </p:nvSpPr>
        <p:spPr>
          <a:xfrm>
            <a:off x="1640983" y="2916812"/>
            <a:ext cx="807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AGS</a:t>
            </a:r>
            <a:endParaRPr lang="zh-TW" altLang="en-US" b="1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619DA4B9-A899-C8C6-07EF-B96BEE26560B}"/>
              </a:ext>
            </a:extLst>
          </p:cNvPr>
          <p:cNvSpPr/>
          <p:nvPr/>
        </p:nvSpPr>
        <p:spPr>
          <a:xfrm>
            <a:off x="3169102" y="3284838"/>
            <a:ext cx="1351006" cy="288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E937C5F9-BCAD-A15D-8432-C888C284FC29}"/>
              </a:ext>
            </a:extLst>
          </p:cNvPr>
          <p:cNvSpPr txBox="1"/>
          <p:nvPr/>
        </p:nvSpPr>
        <p:spPr>
          <a:xfrm>
            <a:off x="3107812" y="2916812"/>
            <a:ext cx="807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MKN</a:t>
            </a:r>
            <a:endParaRPr lang="zh-TW" altLang="en-US" b="1" dirty="0"/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DE1740DA-F6F8-E30C-F311-92EC76225E0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9897" y="1576230"/>
            <a:ext cx="4668849" cy="3729555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F947BCAA-B571-A898-02A7-1F5884BC80CA}"/>
              </a:ext>
            </a:extLst>
          </p:cNvPr>
          <p:cNvSpPr/>
          <p:nvPr/>
        </p:nvSpPr>
        <p:spPr>
          <a:xfrm>
            <a:off x="6727374" y="3569579"/>
            <a:ext cx="1351006" cy="288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8BE1627E-3293-23CB-8617-DF6D70ECA0E8}"/>
              </a:ext>
            </a:extLst>
          </p:cNvPr>
          <p:cNvSpPr txBox="1"/>
          <p:nvPr/>
        </p:nvSpPr>
        <p:spPr>
          <a:xfrm>
            <a:off x="6727374" y="3215352"/>
            <a:ext cx="807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AGS</a:t>
            </a:r>
            <a:endParaRPr lang="zh-TW" altLang="en-US" b="1" dirty="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5D7BB1BF-69B2-AE9A-EF6D-B3C516EFFEA0}"/>
              </a:ext>
            </a:extLst>
          </p:cNvPr>
          <p:cNvSpPr/>
          <p:nvPr/>
        </p:nvSpPr>
        <p:spPr>
          <a:xfrm>
            <a:off x="8255493" y="3583378"/>
            <a:ext cx="1351006" cy="288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EAC9160D-40E4-6A36-A122-CCCF7461DD02}"/>
              </a:ext>
            </a:extLst>
          </p:cNvPr>
          <p:cNvSpPr txBox="1"/>
          <p:nvPr/>
        </p:nvSpPr>
        <p:spPr>
          <a:xfrm>
            <a:off x="8194203" y="3215352"/>
            <a:ext cx="807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MKN</a:t>
            </a:r>
            <a:endParaRPr lang="zh-TW" altLang="en-US" b="1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FF236B58-E8C2-7B5C-91CF-BD621CBB5C06}"/>
              </a:ext>
            </a:extLst>
          </p:cNvPr>
          <p:cNvSpPr txBox="1"/>
          <p:nvPr/>
        </p:nvSpPr>
        <p:spPr>
          <a:xfrm>
            <a:off x="981462" y="1524617"/>
            <a:ext cx="1216592" cy="38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A20</a:t>
            </a:r>
            <a:endParaRPr lang="zh-TW" altLang="en-US" b="1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9210ACD3-2DE6-F8FD-E6AB-EA25C1BC1580}"/>
              </a:ext>
            </a:extLst>
          </p:cNvPr>
          <p:cNvSpPr txBox="1"/>
          <p:nvPr/>
        </p:nvSpPr>
        <p:spPr>
          <a:xfrm>
            <a:off x="6522732" y="1576230"/>
            <a:ext cx="1216592" cy="38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GAPDH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22386816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0B633B8-39A4-B158-2FE0-99C19DFC0F24}"/>
              </a:ext>
            </a:extLst>
          </p:cNvPr>
          <p:cNvSpPr txBox="1"/>
          <p:nvPr/>
        </p:nvSpPr>
        <p:spPr>
          <a:xfrm>
            <a:off x="-1" y="0"/>
            <a:ext cx="20020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Figure 6D</a:t>
            </a:r>
            <a:endParaRPr lang="zh-TW" altLang="en-US" sz="3200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EAFA4347-AED6-931D-D9BC-A77EDC9C6FD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73" y="1243036"/>
            <a:ext cx="5892247" cy="4712301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A3C7C313-C914-80AE-203B-546061611B25}"/>
              </a:ext>
            </a:extLst>
          </p:cNvPr>
          <p:cNvSpPr/>
          <p:nvPr/>
        </p:nvSpPr>
        <p:spPr>
          <a:xfrm>
            <a:off x="1121001" y="4784460"/>
            <a:ext cx="1750741" cy="2118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7D1B26B7-CB0D-C71F-3E52-A382494449E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243036"/>
            <a:ext cx="5959954" cy="476645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4378F0D2-F5AC-42BA-49B9-F3BE4C80EB4C}"/>
              </a:ext>
            </a:extLst>
          </p:cNvPr>
          <p:cNvSpPr/>
          <p:nvPr/>
        </p:nvSpPr>
        <p:spPr>
          <a:xfrm>
            <a:off x="7081908" y="3800038"/>
            <a:ext cx="1750741" cy="2118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23AA7A9F-4F9D-4F6B-0248-F1D778278CA6}"/>
              </a:ext>
            </a:extLst>
          </p:cNvPr>
          <p:cNvSpPr txBox="1"/>
          <p:nvPr/>
        </p:nvSpPr>
        <p:spPr>
          <a:xfrm>
            <a:off x="495742" y="1243036"/>
            <a:ext cx="2183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A20</a:t>
            </a:r>
            <a:endParaRPr lang="zh-TW" altLang="en-US" b="1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60234890-5A61-BB29-4E22-82B083764D8D}"/>
              </a:ext>
            </a:extLst>
          </p:cNvPr>
          <p:cNvSpPr txBox="1"/>
          <p:nvPr/>
        </p:nvSpPr>
        <p:spPr>
          <a:xfrm>
            <a:off x="6496279" y="1243036"/>
            <a:ext cx="2183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err="1"/>
              <a:t>Occludin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3577763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640CFCB1-4943-1DF1-4355-3AF8B05B6273}"/>
              </a:ext>
            </a:extLst>
          </p:cNvPr>
          <p:cNvSpPr txBox="1"/>
          <p:nvPr/>
        </p:nvSpPr>
        <p:spPr>
          <a:xfrm>
            <a:off x="-1" y="0"/>
            <a:ext cx="20020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Figure 6F</a:t>
            </a:r>
            <a:endParaRPr lang="zh-TW" altLang="en-US" sz="3200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7A12B494-828D-DB7D-83A1-584F3E6D95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210" y="761162"/>
            <a:ext cx="3599688" cy="2878836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21C705D5-B8E5-E040-E17C-A707AFE191EF}"/>
              </a:ext>
            </a:extLst>
          </p:cNvPr>
          <p:cNvSpPr/>
          <p:nvPr/>
        </p:nvSpPr>
        <p:spPr>
          <a:xfrm>
            <a:off x="593383" y="1440639"/>
            <a:ext cx="2685536" cy="2224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CA27FC79-2B27-C8F8-034B-E327BF730C4A}"/>
              </a:ext>
            </a:extLst>
          </p:cNvPr>
          <p:cNvSpPr txBox="1"/>
          <p:nvPr/>
        </p:nvSpPr>
        <p:spPr>
          <a:xfrm>
            <a:off x="1746681" y="1061698"/>
            <a:ext cx="988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A20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C957BB2C-C7D1-AA31-41BC-E2F62E535CA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805" y="769677"/>
            <a:ext cx="3599688" cy="2878836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BFB45E1F-5A29-B0E2-90F4-12C170E4D518}"/>
              </a:ext>
            </a:extLst>
          </p:cNvPr>
          <p:cNvSpPr/>
          <p:nvPr/>
        </p:nvSpPr>
        <p:spPr>
          <a:xfrm>
            <a:off x="4436335" y="1370896"/>
            <a:ext cx="2685536" cy="2224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D62881EE-F6C7-F245-54B8-44F066B1BE7A}"/>
              </a:ext>
            </a:extLst>
          </p:cNvPr>
          <p:cNvSpPr txBox="1"/>
          <p:nvPr/>
        </p:nvSpPr>
        <p:spPr>
          <a:xfrm>
            <a:off x="5589633" y="991955"/>
            <a:ext cx="988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P-ERK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id="{970ED1FE-4A57-8FA6-3F8F-2F44BBB44F8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9897" y="3843963"/>
            <a:ext cx="3599688" cy="2878836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DA28EBF6-6E74-0758-AC60-9D0181B00011}"/>
              </a:ext>
            </a:extLst>
          </p:cNvPr>
          <p:cNvSpPr/>
          <p:nvPr/>
        </p:nvSpPr>
        <p:spPr>
          <a:xfrm>
            <a:off x="4613449" y="5388414"/>
            <a:ext cx="2685536" cy="2224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74F04F3F-2077-CBB3-89E1-4FFB6371DCF2}"/>
              </a:ext>
            </a:extLst>
          </p:cNvPr>
          <p:cNvSpPr txBox="1"/>
          <p:nvPr/>
        </p:nvSpPr>
        <p:spPr>
          <a:xfrm>
            <a:off x="5519612" y="5001236"/>
            <a:ext cx="144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Total-ERK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E15F9F4D-0B5E-0DBE-CF4C-77F8BA62D35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4059" y="703590"/>
            <a:ext cx="3599688" cy="2878836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4E3E9C27-C635-6D60-8C7B-FCA38DEBE824}"/>
              </a:ext>
            </a:extLst>
          </p:cNvPr>
          <p:cNvSpPr/>
          <p:nvPr/>
        </p:nvSpPr>
        <p:spPr>
          <a:xfrm>
            <a:off x="8509945" y="1580776"/>
            <a:ext cx="2685536" cy="2224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255B9881-4BC4-45AB-BCAB-0B0C7D48AF81}"/>
              </a:ext>
            </a:extLst>
          </p:cNvPr>
          <p:cNvSpPr txBox="1"/>
          <p:nvPr/>
        </p:nvSpPr>
        <p:spPr>
          <a:xfrm>
            <a:off x="9663243" y="1201835"/>
            <a:ext cx="988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P-Rock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17" name="圖片 16">
            <a:extLst>
              <a:ext uri="{FF2B5EF4-FFF2-40B4-BE49-F238E27FC236}">
                <a16:creationId xmlns:a16="http://schemas.microsoft.com/office/drawing/2014/main" id="{C2BC34BF-6FE4-26DB-B0EB-707A5C8F905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4059" y="3793737"/>
            <a:ext cx="3599688" cy="2878836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DF4C3DDA-4E32-F7BA-DF83-CD4EB4425F06}"/>
              </a:ext>
            </a:extLst>
          </p:cNvPr>
          <p:cNvSpPr/>
          <p:nvPr/>
        </p:nvSpPr>
        <p:spPr>
          <a:xfrm>
            <a:off x="8538777" y="4736827"/>
            <a:ext cx="2780272" cy="2347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A3159270-CE89-AE75-8596-EBD7B1759709}"/>
              </a:ext>
            </a:extLst>
          </p:cNvPr>
          <p:cNvSpPr txBox="1"/>
          <p:nvPr/>
        </p:nvSpPr>
        <p:spPr>
          <a:xfrm>
            <a:off x="9692075" y="4370242"/>
            <a:ext cx="988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Rock</a:t>
            </a:r>
            <a:endParaRPr lang="zh-TW" altLang="en-US" dirty="0">
              <a:solidFill>
                <a:srgbClr val="FF0000"/>
              </a:solidFill>
            </a:endParaRPr>
          </a:p>
        </p:txBody>
      </p:sp>
      <p:pic>
        <p:nvPicPr>
          <p:cNvPr id="20" name="圖片 19">
            <a:extLst>
              <a:ext uri="{FF2B5EF4-FFF2-40B4-BE49-F238E27FC236}">
                <a16:creationId xmlns:a16="http://schemas.microsoft.com/office/drawing/2014/main" id="{924B18C5-A604-6AFC-EAA4-4AD657461841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211" y="3826188"/>
            <a:ext cx="3599688" cy="2878836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551717AC-AD0D-4353-12A4-807E18091ED4}"/>
              </a:ext>
            </a:extLst>
          </p:cNvPr>
          <p:cNvSpPr/>
          <p:nvPr/>
        </p:nvSpPr>
        <p:spPr>
          <a:xfrm>
            <a:off x="646412" y="4369742"/>
            <a:ext cx="2685536" cy="2224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02A48482-5F6C-AE6C-21EC-036CFF762644}"/>
              </a:ext>
            </a:extLst>
          </p:cNvPr>
          <p:cNvSpPr txBox="1"/>
          <p:nvPr/>
        </p:nvSpPr>
        <p:spPr>
          <a:xfrm>
            <a:off x="1478435" y="4015515"/>
            <a:ext cx="12397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err="1">
                <a:solidFill>
                  <a:srgbClr val="FF0000"/>
                </a:solidFill>
              </a:rPr>
              <a:t>Occludin</a:t>
            </a:r>
            <a:endParaRPr lang="zh-TW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2383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DA6EFC64-49E7-58B5-0AF4-A9E1D2E74B9C}"/>
              </a:ext>
            </a:extLst>
          </p:cNvPr>
          <p:cNvSpPr txBox="1"/>
          <p:nvPr/>
        </p:nvSpPr>
        <p:spPr>
          <a:xfrm>
            <a:off x="-1" y="0"/>
            <a:ext cx="20020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Figure 7B</a:t>
            </a:r>
            <a:endParaRPr lang="zh-TW" altLang="en-US" sz="3200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3BA83031-78DF-927F-536F-649F1C71E9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117" y="911283"/>
            <a:ext cx="3599688" cy="2878836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C37E9401-0FF0-0284-F029-B3A15CD4388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36157"/>
          <a:stretch/>
        </p:blipFill>
        <p:spPr>
          <a:xfrm>
            <a:off x="5307281" y="942033"/>
            <a:ext cx="4635255" cy="2366690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2EF38CEE-2F1C-C34A-4D63-95BAC18CD01F}"/>
              </a:ext>
            </a:extLst>
          </p:cNvPr>
          <p:cNvSpPr/>
          <p:nvPr/>
        </p:nvSpPr>
        <p:spPr>
          <a:xfrm>
            <a:off x="1251283" y="2166204"/>
            <a:ext cx="2537254" cy="255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A3607A37-F446-ACD8-3789-CA86CCA0C2E0}"/>
              </a:ext>
            </a:extLst>
          </p:cNvPr>
          <p:cNvSpPr/>
          <p:nvPr/>
        </p:nvSpPr>
        <p:spPr>
          <a:xfrm>
            <a:off x="6502996" y="2042493"/>
            <a:ext cx="2269526" cy="2286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594A6A69-91D8-8E8C-B8E5-C008A68554E5}"/>
              </a:ext>
            </a:extLst>
          </p:cNvPr>
          <p:cNvSpPr txBox="1"/>
          <p:nvPr/>
        </p:nvSpPr>
        <p:spPr>
          <a:xfrm>
            <a:off x="1251283" y="1263286"/>
            <a:ext cx="996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IP:A20</a:t>
            </a:r>
            <a:endParaRPr lang="zh-TW" altLang="en-US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68C7B05F-D9E7-489D-BAA9-CFD58923A42B}"/>
              </a:ext>
            </a:extLst>
          </p:cNvPr>
          <p:cNvSpPr txBox="1"/>
          <p:nvPr/>
        </p:nvSpPr>
        <p:spPr>
          <a:xfrm>
            <a:off x="6263740" y="663346"/>
            <a:ext cx="996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IP: </a:t>
            </a:r>
            <a:r>
              <a:rPr lang="en-US" altLang="zh-TW" dirty="0" err="1"/>
              <a:t>RhoA</a:t>
            </a:r>
            <a:endParaRPr lang="zh-TW" altLang="en-US" dirty="0"/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id="{0B46825A-1FE6-1EE5-219A-7AE9E27E637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117" y="3901689"/>
            <a:ext cx="3599688" cy="2878836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290FC8D5-CD9C-7D06-F621-AEA029F938C2}"/>
              </a:ext>
            </a:extLst>
          </p:cNvPr>
          <p:cNvSpPr/>
          <p:nvPr/>
        </p:nvSpPr>
        <p:spPr>
          <a:xfrm>
            <a:off x="1470076" y="5213420"/>
            <a:ext cx="2537254" cy="255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2A91B5B4-9C9A-148D-20B8-EA28B2B3DF4B}"/>
              </a:ext>
            </a:extLst>
          </p:cNvPr>
          <p:cNvSpPr txBox="1"/>
          <p:nvPr/>
        </p:nvSpPr>
        <p:spPr>
          <a:xfrm>
            <a:off x="1470076" y="4589893"/>
            <a:ext cx="1717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Input: A20</a:t>
            </a:r>
            <a:endParaRPr lang="zh-TW" altLang="en-US" dirty="0"/>
          </a:p>
        </p:txBody>
      </p:sp>
      <p:pic>
        <p:nvPicPr>
          <p:cNvPr id="16" name="圖片 15">
            <a:extLst>
              <a:ext uri="{FF2B5EF4-FFF2-40B4-BE49-F238E27FC236}">
                <a16:creationId xmlns:a16="http://schemas.microsoft.com/office/drawing/2014/main" id="{2FC787F3-1E09-122D-8AC4-AE753715128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6508" y="3655058"/>
            <a:ext cx="3599688" cy="2878836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429D7CB6-2AFE-01E1-2090-27017F0D03A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29051" y="3655058"/>
            <a:ext cx="3599688" cy="2878836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A7030D0D-73A5-851B-16CE-595AD8C2D254}"/>
              </a:ext>
            </a:extLst>
          </p:cNvPr>
          <p:cNvSpPr/>
          <p:nvPr/>
        </p:nvSpPr>
        <p:spPr>
          <a:xfrm>
            <a:off x="4953655" y="4738707"/>
            <a:ext cx="2537254" cy="255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58164734-F820-F5A6-3326-53AD97C38919}"/>
              </a:ext>
            </a:extLst>
          </p:cNvPr>
          <p:cNvSpPr/>
          <p:nvPr/>
        </p:nvSpPr>
        <p:spPr>
          <a:xfrm>
            <a:off x="8971495" y="4370689"/>
            <a:ext cx="2537254" cy="255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3ABFDD1D-C104-D2EC-F513-376F716B74C8}"/>
              </a:ext>
            </a:extLst>
          </p:cNvPr>
          <p:cNvSpPr txBox="1"/>
          <p:nvPr/>
        </p:nvSpPr>
        <p:spPr>
          <a:xfrm>
            <a:off x="4674778" y="3642885"/>
            <a:ext cx="1717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err="1"/>
              <a:t>Inpute</a:t>
            </a:r>
            <a:r>
              <a:rPr lang="en-US" altLang="zh-TW" dirty="0"/>
              <a:t>: </a:t>
            </a:r>
            <a:r>
              <a:rPr lang="en-US" altLang="zh-TW" dirty="0" err="1"/>
              <a:t>RhoA</a:t>
            </a:r>
            <a:endParaRPr lang="zh-TW" altLang="en-US" dirty="0"/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6B7AA396-0E7D-6234-F494-452C37C9B005}"/>
              </a:ext>
            </a:extLst>
          </p:cNvPr>
          <p:cNvSpPr txBox="1"/>
          <p:nvPr/>
        </p:nvSpPr>
        <p:spPr>
          <a:xfrm>
            <a:off x="8816186" y="3402554"/>
            <a:ext cx="1717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err="1"/>
              <a:t>Inpute</a:t>
            </a:r>
            <a:r>
              <a:rPr lang="en-US" altLang="zh-TW" dirty="0"/>
              <a:t>: GAPDH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7164669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60067F08-0C56-05E2-A25A-5603C1144BC8}"/>
              </a:ext>
            </a:extLst>
          </p:cNvPr>
          <p:cNvSpPr txBox="1"/>
          <p:nvPr/>
        </p:nvSpPr>
        <p:spPr>
          <a:xfrm>
            <a:off x="-1" y="0"/>
            <a:ext cx="47452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3200" dirty="0"/>
              <a:t>Supplementary Figure S5</a:t>
            </a:r>
            <a:endParaRPr lang="zh-TW" altLang="en-US" sz="3200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AF74F015-C403-220B-13FE-DC3906026C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555" y="1198749"/>
            <a:ext cx="4897739" cy="3916947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C57847CE-AD11-46C4-763E-42BD948499A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7160" y="1285572"/>
            <a:ext cx="4722631" cy="377690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AAC0F921-0CFF-B0EF-60E1-DA440864E3DD}"/>
              </a:ext>
            </a:extLst>
          </p:cNvPr>
          <p:cNvSpPr/>
          <p:nvPr/>
        </p:nvSpPr>
        <p:spPr>
          <a:xfrm>
            <a:off x="2809103" y="1812324"/>
            <a:ext cx="1103870" cy="2718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4DFBD4C0-FA78-F714-B03B-8051E408A0D7}"/>
              </a:ext>
            </a:extLst>
          </p:cNvPr>
          <p:cNvSpPr/>
          <p:nvPr/>
        </p:nvSpPr>
        <p:spPr>
          <a:xfrm>
            <a:off x="7805352" y="1664369"/>
            <a:ext cx="1103870" cy="2718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5182839D-2D31-76BC-8A27-6F611F0EBDE9}"/>
              </a:ext>
            </a:extLst>
          </p:cNvPr>
          <p:cNvSpPr txBox="1"/>
          <p:nvPr/>
        </p:nvSpPr>
        <p:spPr>
          <a:xfrm>
            <a:off x="3097427" y="1433384"/>
            <a:ext cx="98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A20</a:t>
            </a: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FDDCF75D-8351-6CAE-4746-4317FF3074AE}"/>
              </a:ext>
            </a:extLst>
          </p:cNvPr>
          <p:cNvSpPr txBox="1"/>
          <p:nvPr/>
        </p:nvSpPr>
        <p:spPr>
          <a:xfrm>
            <a:off x="7879493" y="1318380"/>
            <a:ext cx="988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solidFill>
                  <a:srgbClr val="FF0000"/>
                </a:solidFill>
              </a:rPr>
              <a:t>GAPDH</a:t>
            </a:r>
            <a:endParaRPr lang="zh-TW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8575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46</Words>
  <Application>Microsoft Office PowerPoint</Application>
  <PresentationFormat>寬螢幕</PresentationFormat>
  <Paragraphs>29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Guest</dc:creator>
  <cp:lastModifiedBy>延盛 沈</cp:lastModifiedBy>
  <cp:revision>4</cp:revision>
  <dcterms:created xsi:type="dcterms:W3CDTF">2025-08-06T04:16:40Z</dcterms:created>
  <dcterms:modified xsi:type="dcterms:W3CDTF">2025-09-04T16:14:25Z</dcterms:modified>
</cp:coreProperties>
</file>